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128" d="100"/>
          <a:sy n="128" d="100"/>
        </p:scale>
        <p:origin x="17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4905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919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21971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7996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5864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1247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524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3472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5608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28900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8262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00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F2380AA-7698-5348-9FCB-DB23E7A513C5}"/>
              </a:ext>
            </a:extLst>
          </p:cNvPr>
          <p:cNvSpPr txBox="1"/>
          <p:nvPr/>
        </p:nvSpPr>
        <p:spPr>
          <a:xfrm>
            <a:off x="102952" y="5621291"/>
            <a:ext cx="8599341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Mov</a:t>
            </a:r>
            <a:r>
              <a:rPr lang="en-US" altLang="ja-JP" sz="1100" b="1">
                <a:latin typeface="Arial" panose="020B0604020202020204" pitchFamily="34" charset="0"/>
                <a:cs typeface="Arial" panose="020B0604020202020204" pitchFamily="34" charset="0"/>
              </a:rPr>
              <a:t>. 3</a:t>
            </a:r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 Video of a marmoset tracking when it hides behind something.</a:t>
            </a:r>
            <a:endParaRPr lang="en-US" altLang="ja-JP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a) Raw video frame. (b) 3D coordinates of marmosets detected using Lidar. White point: centroid of marmosets, white box: virtual space of the cage. (c) Location of marmosets on video frame detected using Yolo, box: detected marmosets. (d) 3D coordinate of marmosets calculated using video tracking, colored point: coordinate of marmoset. (e, f) Individual information added to C and D using face identification</a:t>
            </a:r>
            <a:r>
              <a:rPr lang="en-US" altLang="ja-JP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green: marmoset A, red: marmoset B, yellow: marmoset C.</a:t>
            </a:r>
            <a:endParaRPr lang="ja-JP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media3">
            <a:hlinkClick r:id="" action="ppaction://media"/>
            <a:extLst>
              <a:ext uri="{FF2B5EF4-FFF2-40B4-BE49-F238E27FC236}">
                <a16:creationId xmlns:a16="http://schemas.microsoft.com/office/drawing/2014/main" id="{AC21A18D-2302-A044-379A-8F1CC3E691B0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71601" y="0"/>
            <a:ext cx="7043516" cy="52826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19416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104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18</Words>
  <Application>Microsoft Macintosh PowerPoint</Application>
  <PresentationFormat>画面に合わせる (4:3)</PresentationFormat>
  <Paragraphs>2</Paragraphs>
  <Slides>1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晃海 圦本</dc:creator>
  <cp:lastModifiedBy>晃海 圦本</cp:lastModifiedBy>
  <cp:revision>7</cp:revision>
  <dcterms:created xsi:type="dcterms:W3CDTF">2023-07-18T01:28:01Z</dcterms:created>
  <dcterms:modified xsi:type="dcterms:W3CDTF">2024-01-18T11:42:42Z</dcterms:modified>
</cp:coreProperties>
</file>